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A623918-15EC-4508-A411-06EAA50DD05B}" v="2" dt="2022-11-05T13:06:32.09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86" d="100"/>
          <a:sy n="86" d="100"/>
        </p:scale>
        <p:origin x="514" y="91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hosh, Souvik" userId="eecea02d-3ead-4d19-9bc6-c58aca595acd" providerId="ADAL" clId="{FA623918-15EC-4508-A411-06EAA50DD05B}"/>
    <pc:docChg chg="custSel modSld">
      <pc:chgData name="Ghosh, Souvik" userId="eecea02d-3ead-4d19-9bc6-c58aca595acd" providerId="ADAL" clId="{FA623918-15EC-4508-A411-06EAA50DD05B}" dt="2022-11-05T13:07:19.100" v="216" actId="20577"/>
      <pc:docMkLst>
        <pc:docMk/>
      </pc:docMkLst>
      <pc:sldChg chg="addSp modSp mod">
        <pc:chgData name="Ghosh, Souvik" userId="eecea02d-3ead-4d19-9bc6-c58aca595acd" providerId="ADAL" clId="{FA623918-15EC-4508-A411-06EAA50DD05B}" dt="2022-11-05T13:07:19.100" v="216" actId="20577"/>
        <pc:sldMkLst>
          <pc:docMk/>
          <pc:sldMk cId="2440304005" sldId="256"/>
        </pc:sldMkLst>
        <pc:spChg chg="add mod">
          <ac:chgData name="Ghosh, Souvik" userId="eecea02d-3ead-4d19-9bc6-c58aca595acd" providerId="ADAL" clId="{FA623918-15EC-4508-A411-06EAA50DD05B}" dt="2022-11-05T13:07:19.100" v="216" actId="20577"/>
          <ac:spMkLst>
            <pc:docMk/>
            <pc:sldMk cId="2440304005" sldId="256"/>
            <ac:spMk id="4" creationId="{F27D7394-96B0-ECEB-FE01-69DADADA5145}"/>
          </ac:spMkLst>
        </pc:spChg>
        <pc:picChg chg="mod">
          <ac:chgData name="Ghosh, Souvik" userId="eecea02d-3ead-4d19-9bc6-c58aca595acd" providerId="ADAL" clId="{FA623918-15EC-4508-A411-06EAA50DD05B}" dt="2022-10-29T16:10:45.317" v="1" actId="1076"/>
          <ac:picMkLst>
            <pc:docMk/>
            <pc:sldMk cId="2440304005" sldId="256"/>
            <ac:picMk id="3" creationId="{A87D2B3A-3CD9-4F92-BEDF-BA2CD239074C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369365-1556-4A08-A398-FBDE2B20C42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C6C8DB1-AD9C-4263-A719-668FDE9B9E6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93D2FA-7D41-464C-8B8A-ADFB173B28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085E9-18D9-49B2-A678-50196318FC9B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B00211-84E8-4226-BD80-1BF3AFFEE2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0DFF93-F40C-4650-B549-7CEF101B96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26C0B-0D24-4C44-858C-7DA2886B5A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03333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AB2A95-EAFC-4CEA-A6CA-8860C1CBE0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3690864-5F32-4AD7-9AA9-C3649CA4F47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AD6BDE-CB52-469F-902C-5965A82D1C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085E9-18D9-49B2-A678-50196318FC9B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B03405-7E59-453E-8777-381AB50F64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67F364-120E-4AD7-B61B-4664002CDF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26C0B-0D24-4C44-858C-7DA2886B5A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07045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4FE0E22-D16C-4589-A223-0E26B08E172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A1A4AE2-B208-4048-A849-F471EE0F30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C5D53C-EE79-43B0-86B4-4A53810CFD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085E9-18D9-49B2-A678-50196318FC9B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469143-6BCC-494A-97CF-F895496B93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597CF4-619F-41E6-8724-238E373ADF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26C0B-0D24-4C44-858C-7DA2886B5A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92406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6BA27A-3CA0-4F15-9F99-0E201B2043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BB1938C-B0C6-45A1-B2AA-5F836978C34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168A54-7CAC-40F5-9107-BF5ED48424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085E9-18D9-49B2-A678-50196318FC9B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127100-5A52-4A56-94D6-27660059B7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A28EC7-9C9B-4E27-99EE-57448B496A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26C0B-0D24-4C44-858C-7DA2886B5A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99531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295B58-29A6-40D1-AE9A-3DE6B79218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DC17BFA-AEDC-4203-B4A4-BCD65E199F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150F2A-3B3D-4897-868E-8C8D8B7DD6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085E9-18D9-49B2-A678-50196318FC9B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AC4E3A-851F-4410-8B6F-FC4A521913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12B5E6-08E0-4211-B62B-EF9F20708E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26C0B-0D24-4C44-858C-7DA2886B5A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26558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5C084E-3977-4CE7-BE93-FF0D725ABF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7333ED9-04FF-4BC9-82D0-01ECBCF1AC3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2A1CCC6-8E28-4482-961D-812592205D9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3CF459-FF9B-4FD4-AA93-E65747F454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085E9-18D9-49B2-A678-50196318FC9B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F8E188E-0A65-4A09-8125-999EFA148B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10032C8-A7B2-4D7E-A6D8-497B12E7EE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26C0B-0D24-4C44-858C-7DA2886B5A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72338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4E30AC-66FA-46F8-8408-30762F5A47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77D9549-CD2C-414C-BB02-C136ED155C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B993B8D-DBC1-403A-B31C-E6A95BE576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43E9B94-7E1A-440D-83D0-75C61F9FDF5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0488BA6-EAEA-4119-A6B7-33FD0ACE292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9C15EEC-7B15-4C3D-855D-462658CE88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085E9-18D9-49B2-A678-50196318FC9B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83DD068-4E40-4714-80A6-A08D8314B5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3434FDD-72FB-4B59-BEC4-F34EC817FC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26C0B-0D24-4C44-858C-7DA2886B5A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96480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BF35C8-F8A6-40FA-83DC-DDDF2D6058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99B815F-A0A5-4810-A0AC-06D0E0BCA4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085E9-18D9-49B2-A678-50196318FC9B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327BBEB-0160-48DE-B4A6-145780500D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3BE7E99-7076-4056-9D8C-BDA45B528D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26C0B-0D24-4C44-858C-7DA2886B5A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17867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66DEDB4-50E0-4BC5-BAB1-3223C74471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085E9-18D9-49B2-A678-50196318FC9B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90210F6-EE66-4540-AB74-8D8C77B9AD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C444989-50FF-46A6-B9BF-C35E0F8565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26C0B-0D24-4C44-858C-7DA2886B5A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35787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B7420F-9A60-4D5D-A813-04EC5A1160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2779C7E-F1FF-43F2-A41F-DD81FB44862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514C018-51EE-4387-AE22-4C5C8E459A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CF8E50A-7785-45C6-BD2B-C357B975D7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085E9-18D9-49B2-A678-50196318FC9B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FE93225-5A52-4AEF-903F-35C9BC10AE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D8BD809-D031-40E0-AF0A-44D6451B0D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26C0B-0D24-4C44-858C-7DA2886B5A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354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E5DF5E-EBCF-4DA3-947A-0E8BB13431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2FD8B0D-880F-4AE8-A2C5-BB2589F94E2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19FAE31-242E-4F3D-BC50-8443D53DAD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B82EE7B-3B61-4EF9-9EAB-4E14AF99D2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085E9-18D9-49B2-A678-50196318FC9B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5AFC303-6B38-4062-8259-2970A0F424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2612A26-1467-401E-868B-A078112849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26C0B-0D24-4C44-858C-7DA2886B5A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7971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D9E046C-CC86-445F-8C70-2833D8A1D9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B61C3EB-E81B-4A44-90B3-46D13A06C7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BEF5CA-501D-42F6-9D12-6918958257C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B085E9-18D9-49B2-A678-50196318FC9B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237DFC-C326-485D-BD6C-10738745223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9E241D-19A4-478B-B66F-D8DC36CEDD9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326C0B-0D24-4C44-858C-7DA2886B5A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93538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A87D2B3A-3CD9-4F92-BEDF-BA2CD239074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2519" y="1540125"/>
            <a:ext cx="7866962" cy="506629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27D7394-96B0-ECEB-FE01-69DADADA5145}"/>
              </a:ext>
            </a:extLst>
          </p:cNvPr>
          <p:cNvSpPr txBox="1"/>
          <p:nvPr/>
        </p:nvSpPr>
        <p:spPr>
          <a:xfrm>
            <a:off x="285750" y="247463"/>
            <a:ext cx="11582400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400" b="1">
                <a:latin typeface="Palatino Linotype" panose="0204050205050503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S1. </a:t>
            </a:r>
            <a:r>
              <a:rPr 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Map of the Dominican Republic showing the porcine sampling sites. The pig farm in the municipality of Cabrera, Pedro Brand, and Villa </a:t>
            </a:r>
            <a:r>
              <a:rPr lang="en-US" sz="14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Mella</a:t>
            </a:r>
            <a:r>
              <a:rPr 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is highlighted with green, blue, and orange pins, respectively. The map was adapted from www.google.com/maps (accessed June 2, 2022). </a:t>
            </a:r>
            <a:r>
              <a:rPr lang="en-US" sz="1400" b="1" i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Inset:</a:t>
            </a:r>
            <a:r>
              <a:rPr 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The geographical location of Dominican Republic (encircled and shown with red) in the Greater Antilles, Caribbean region. The map was adapted from commons.wikimedia.org/wiki/</a:t>
            </a:r>
            <a:r>
              <a:rPr lang="en-US" sz="14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File:Dominican_Republic_in_the_world</a:t>
            </a:r>
            <a:r>
              <a:rPr 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_(W3).</a:t>
            </a:r>
            <a:r>
              <a:rPr lang="en-US" sz="14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svg</a:t>
            </a:r>
            <a:r>
              <a:rPr 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(author: TUBS, commons.wikimedia.org/wiki/</a:t>
            </a:r>
            <a:r>
              <a:rPr lang="en-US" sz="14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User:TUBS</a:t>
            </a:r>
            <a:r>
              <a:rPr 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) on 15</a:t>
            </a:r>
            <a:r>
              <a:rPr lang="en-US" sz="14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th</a:t>
            </a:r>
            <a:r>
              <a:rPr 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October 2022 and is licensed for free sharing and adaptation under the Creative Commons Attribution-Share Alike 3.0 </a:t>
            </a:r>
            <a:r>
              <a:rPr lang="en-US" sz="14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Unported</a:t>
            </a:r>
            <a:r>
              <a:rPr 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license.</a:t>
            </a:r>
          </a:p>
        </p:txBody>
      </p:sp>
    </p:spTree>
    <p:extLst>
      <p:ext uri="{BB962C8B-B14F-4D97-AF65-F5344CB8AC3E}">
        <p14:creationId xmlns:p14="http://schemas.microsoft.com/office/powerpoint/2010/main" val="24403040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7C1558744F9E84F9DB11EE653CC9A55" ma:contentTypeVersion="14" ma:contentTypeDescription="Create a new document." ma:contentTypeScope="" ma:versionID="98c9b13aa71c527b7ced6f332a33a861">
  <xsd:schema xmlns:xsd="http://www.w3.org/2001/XMLSchema" xmlns:xs="http://www.w3.org/2001/XMLSchema" xmlns:p="http://schemas.microsoft.com/office/2006/metadata/properties" xmlns:ns3="84958558-c7aa-4a73-8d7b-4bffe5b377e9" xmlns:ns4="ebe390dc-a215-41b8-b9a7-475ecdd00c54" targetNamespace="http://schemas.microsoft.com/office/2006/metadata/properties" ma:root="true" ma:fieldsID="f478b27cdcb62a09c0a4e554e441f71e" ns3:_="" ns4:_="">
    <xsd:import namespace="84958558-c7aa-4a73-8d7b-4bffe5b377e9"/>
    <xsd:import namespace="ebe390dc-a215-41b8-b9a7-475ecdd00c54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KeyPoints" minOccurs="0"/>
                <xsd:element ref="ns4:MediaServiceKeyPoints" minOccurs="0"/>
                <xsd:element ref="ns4:MediaServiceAutoTags" minOccurs="0"/>
                <xsd:element ref="ns4:MediaServiceOCR" minOccurs="0"/>
                <xsd:element ref="ns4:MediaServiceGenerationTime" minOccurs="0"/>
                <xsd:element ref="ns4:MediaServiceEventHashCode" minOccurs="0"/>
                <xsd:element ref="ns4:MediaServiceDateTaken" minOccurs="0"/>
                <xsd:element ref="ns4:MediaLengthInSeconds" minOccurs="0"/>
                <xsd:element ref="ns4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4958558-c7aa-4a73-8d7b-4bffe5b377e9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description="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description="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be390dc-a215-41b8-b9a7-475ecdd00c54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5" nillable="true" ma:displayName="Tags" ma:internalName="MediaServiceAutoTags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9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20" nillable="true" ma:displayName="Length (seconds)" ma:internalName="MediaLengthInSeconds" ma:readOnly="true">
      <xsd:simpleType>
        <xsd:restriction base="dms:Unknown"/>
      </xsd:simpleType>
    </xsd:element>
    <xsd:element name="MediaServiceLocation" ma:index="21" nillable="true" ma:displayName="Location" ma:internalName="MediaServiceLocatio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526549F4-793C-42C2-B645-7D4BCD5D1D24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4958558-c7aa-4a73-8d7b-4bffe5b377e9"/>
    <ds:schemaRef ds:uri="ebe390dc-a215-41b8-b9a7-475ecdd00c54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B350A6A3-D0FA-4805-AD94-40E9832745CD}">
  <ds:schemaRefs>
    <ds:schemaRef ds:uri="http://schemas.microsoft.com/office/infopath/2007/PartnerControls"/>
    <ds:schemaRef ds:uri="http://schemas.openxmlformats.org/package/2006/metadata/core-properties"/>
    <ds:schemaRef ds:uri="http://purl.org/dc/terms/"/>
    <ds:schemaRef ds:uri="http://schemas.microsoft.com/office/2006/documentManagement/types"/>
    <ds:schemaRef ds:uri="http://purl.org/dc/dcmitype/"/>
    <ds:schemaRef ds:uri="http://schemas.microsoft.com/office/2006/metadata/properties"/>
    <ds:schemaRef ds:uri="http://purl.org/dc/elements/1.1/"/>
    <ds:schemaRef ds:uri="ebe390dc-a215-41b8-b9a7-475ecdd00c54"/>
    <ds:schemaRef ds:uri="84958558-c7aa-4a73-8d7b-4bffe5b377e9"/>
    <ds:schemaRef ds:uri="http://www.w3.org/XML/1998/namespace"/>
  </ds:schemaRefs>
</ds:datastoreItem>
</file>

<file path=customXml/itemProps3.xml><?xml version="1.0" encoding="utf-8"?>
<ds:datastoreItem xmlns:ds="http://schemas.openxmlformats.org/officeDocument/2006/customXml" ds:itemID="{0AFE8D7F-E429-4FBD-9E9B-2D4E155FD148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152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inor, Kerry</dc:creator>
  <cp:lastModifiedBy>MDPI</cp:lastModifiedBy>
  <cp:revision>3</cp:revision>
  <dcterms:created xsi:type="dcterms:W3CDTF">2022-10-14T14:27:34Z</dcterms:created>
  <dcterms:modified xsi:type="dcterms:W3CDTF">2023-02-04T07:17:2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7C1558744F9E84F9DB11EE653CC9A55</vt:lpwstr>
  </property>
</Properties>
</file>